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2892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57F056-6EE3-46B4-ABB4-5ACC62B3C488}" type="datetimeFigureOut">
              <a:rPr lang="en-GB" smtClean="0"/>
              <a:t>18/02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94A9A3-E31C-41D3-BF06-3277BDD7C7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21194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b="1" dirty="0" smtClean="0"/>
              <a:t>Table 5</a:t>
            </a:r>
            <a:endParaRPr lang="en-GB" dirty="0" smtClean="0"/>
          </a:p>
          <a:p>
            <a:r>
              <a:rPr lang="en-GB" dirty="0" smtClean="0"/>
              <a:t>Demographic and baseline characteristics for non-Hispanic Caucasian HMEZ ITT patients in genetic study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 smtClean="0"/>
              <a:t>Abbreviations:  N=total number of subjects; No.=number of subjects in the specified category; SD=standard deviation</a:t>
            </a:r>
            <a:br>
              <a:rPr lang="en-GB" sz="1200" dirty="0" smtClean="0"/>
            </a:br>
            <a:endParaRPr lang="en-GB" sz="1200" dirty="0" smtClean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5F5CC5-F152-4F81-9D0A-5900F0FA84FB}" type="slidenum">
              <a:rPr lang="en-GB" smtClean="0">
                <a:solidFill>
                  <a:prstClr val="black"/>
                </a:solidFill>
              </a:rPr>
              <a:pPr/>
              <a:t>1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946843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964776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34797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5109282"/>
              </p:ext>
            </p:extLst>
          </p:nvPr>
        </p:nvGraphicFramePr>
        <p:xfrm>
          <a:off x="1371600" y="2180493"/>
          <a:ext cx="4027050" cy="504750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543050"/>
                <a:gridCol w="828000"/>
                <a:gridCol w="828000"/>
                <a:gridCol w="828000"/>
              </a:tblGrid>
              <a:tr h="388268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</a:rPr>
                        <a:t>Male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</a:rPr>
                        <a:t>(N=95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</a:rPr>
                        <a:t>Female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</a:rPr>
                        <a:t>(N=64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</a:rPr>
                        <a:t>All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</a:rPr>
                        <a:t>(N=159)</a:t>
                      </a:r>
                      <a:endParaRPr lang="en-GB" sz="11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Age (years)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No. of subjects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95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6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159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Mean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64.0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60.4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62.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SD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0.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1.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1.0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ody Mass Index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No. of subjects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95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63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58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Mean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34.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36.5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35.1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SD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6.9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7.8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7.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HbA1c (%)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No. of subjects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95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6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159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Mean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0.07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0.07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0.07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SD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0.01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0.01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0.01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Diabetes type n(%)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No. of subjects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95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6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159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ype I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9 (9.5)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7 (10.9)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16 (10.1)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ype II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86 (90.5)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57 (89.1)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143 (89.9)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24 Hour Average Pain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No. of subjects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9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6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156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Mean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5.7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6.0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5.9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413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SD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.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.5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1.3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225881" y="8581292"/>
            <a:ext cx="25571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800" b="1" dirty="0">
                <a:solidFill>
                  <a:prstClr val="black"/>
                </a:solidFill>
              </a:rPr>
              <a:t>Additional file 3</a:t>
            </a:r>
            <a:endParaRPr lang="en-GB" sz="2800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838839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2</Words>
  <Application>Microsoft Office PowerPoint</Application>
  <PresentationFormat>On-screen Show (4:3)</PresentationFormat>
  <Paragraphs>10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PowerPoint Presentation</vt:lpstr>
    </vt:vector>
  </TitlesOfParts>
  <Company>Eli Lilly an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 Sher</dc:creator>
  <cp:lastModifiedBy>Many Sher</cp:lastModifiedBy>
  <cp:revision>1</cp:revision>
  <dcterms:created xsi:type="dcterms:W3CDTF">2014-02-18T12:07:05Z</dcterms:created>
  <dcterms:modified xsi:type="dcterms:W3CDTF">2014-02-18T12:07:28Z</dcterms:modified>
</cp:coreProperties>
</file>